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ACA728-4B04-4C96-906C-6CDA325C7F7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3910EC-78A5-41A3-A341-153532C4A9F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50F8A4-4EC1-4702-956D-679BE4E332A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6CECC7-8CC2-4196-8581-9FAE1740EEF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76113E-F229-4235-9AF9-18E175A776B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9B9A60-67E1-4697-ADEB-B098CF0E99B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2D914E-04BC-4DA4-AAF1-40928A1F780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BD366E-CFC6-4101-87BA-A38F3AB0456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A406CA-552F-4AF7-A358-3D51B2314A7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67830D-9C13-4B75-BF63-B1AE8A3C93F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E23BBC-3DF4-4006-9C5D-B023EB4740B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FC6B32-620C-403D-9A8C-2F96CFE30BB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95EEA9B-B45C-49EE-99DB-11258F93A6A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4" descr="9-2-11(8"/>
          <p:cNvPicPr/>
          <p:nvPr/>
        </p:nvPicPr>
        <p:blipFill>
          <a:blip r:embed="rId1"/>
          <a:stretch/>
        </p:blipFill>
        <p:spPr>
          <a:xfrm>
            <a:off x="1219320" y="762120"/>
            <a:ext cx="3244680" cy="259560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5" descr="9-2-11(8"/>
          <p:cNvPicPr/>
          <p:nvPr/>
        </p:nvPicPr>
        <p:blipFill>
          <a:blip r:embed="rId2"/>
          <a:stretch/>
        </p:blipFill>
        <p:spPr>
          <a:xfrm>
            <a:off x="4876920" y="762120"/>
            <a:ext cx="3244680" cy="2595600"/>
          </a:xfrm>
          <a:prstGeom prst="rect">
            <a:avLst/>
          </a:prstGeom>
          <a:ln w="0">
            <a:noFill/>
          </a:ln>
        </p:spPr>
      </p:pic>
      <p:sp>
        <p:nvSpPr>
          <p:cNvPr id="43" name="Text Box 6"/>
          <p:cNvSpPr/>
          <p:nvPr/>
        </p:nvSpPr>
        <p:spPr>
          <a:xfrm>
            <a:off x="992880" y="4191120"/>
            <a:ext cx="3669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8.3 T cells activated with beads (100X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7"/>
          <p:cNvSpPr/>
          <p:nvPr/>
        </p:nvSpPr>
        <p:spPr>
          <a:xfrm>
            <a:off x="4954680" y="4191120"/>
            <a:ext cx="300456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8.3 T cells activated with bead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+ Treg (1:1 ratio) (100X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3"/>
          <p:cNvSpPr/>
          <p:nvPr/>
        </p:nvSpPr>
        <p:spPr>
          <a:xfrm>
            <a:off x="312120" y="152280"/>
            <a:ext cx="2439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Supplementary Figure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6-09T21:12:32Z</dcterms:created>
  <dc:creator>Sarah Kennett</dc:creator>
  <dc:description/>
  <dc:language>en-US</dc:language>
  <cp:lastModifiedBy>Wei, Cheng-Hong</cp:lastModifiedBy>
  <dcterms:modified xsi:type="dcterms:W3CDTF">2014-07-18T21:03:57Z</dcterms:modified>
  <cp:revision>8</cp:revision>
  <dc:subject/>
  <dc:title>PowerPoint Presentation</dc:title>
</cp:coreProperties>
</file>